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42"/>
    <p:restoredTop sz="94643"/>
  </p:normalViewPr>
  <p:slideViewPr>
    <p:cSldViewPr snapToGrid="0" snapToObjects="1" showGuides="1">
      <p:cViewPr varScale="1">
        <p:scale>
          <a:sx n="99" d="100"/>
          <a:sy n="99" d="100"/>
        </p:scale>
        <p:origin x="192" y="5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EBFB23-8B90-1C4C-83A6-A560B664F6BD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744DF7-7E64-6D46-9343-46E4DBCD06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6251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E6D544-DAD3-E945-B74B-0112C00C74E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1830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E29C74-3CC4-CD48-9697-21CC29E88F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5999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0A14027-1E7E-4E40-9768-0731DF69E8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1" indent="0" algn="ctr">
              <a:buNone/>
              <a:defRPr sz="2000"/>
            </a:lvl2pPr>
            <a:lvl3pPr marL="914361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4" indent="0" algn="ctr">
              <a:buNone/>
              <a:defRPr sz="1600"/>
            </a:lvl5pPr>
            <a:lvl6pPr marL="2285904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7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07F80E-20AD-524C-AB13-A55EBCBFE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1D3D7F3-BED0-3C4C-949E-CD47155DD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20819E-28CA-BD46-A33F-3EA2C3796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8354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A766B4-1508-2F4A-BA32-9FA788A9CE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E7F7456-FDDE-524A-B268-0B75A8EF85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DE9EAD-B6CD-C74A-AB84-5470937BD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360F9B4-4472-C84C-8EF1-C5C757D55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7D1F63-2CD4-3C41-ABE1-EE7096B29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760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61611F9-B15E-C344-AE50-9EBC0FC229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471A506-D4E7-284E-82F4-1A17FC5983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584C93-F996-A540-9C07-F3DAA4BA2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F3C382-C625-A54F-BF19-87BCD44E3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B3EEB8-4950-D444-A979-9627F6D87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953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16677B-D6ED-6B4E-81C2-DF2C37A155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5E834D8-83D0-BB4A-B8A4-8DDD743726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A3E56D9-BAC4-5B4A-88AF-9BC2330E5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28DDE4-7B68-CA47-B43E-1E7D947F5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B20F28C-CB75-4E4D-A8EE-B1DB4CDF8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2051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B6D271-6ED4-F343-8F9C-548782D983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5999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3C8E2D7-C4F0-2E47-BCC3-1591264A42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35771F8-6F2C-5844-8513-46244D748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6957DB-B138-5047-B2FB-2BC8C234F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46FCEA-0C8C-DD44-89DB-9920EB7A1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5265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2D09EE-04FC-A140-9A99-9DF81D878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1187043-9D2E-0142-BC3C-62703E1B1D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92CFF8D-8ED8-174C-A90E-BF39335986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17EB808-3AB0-D045-AFF5-09CB016AE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9F9E336-84D4-AF40-8074-8A65DA3A4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4CAFFC9-2BAF-E149-894C-432A0112E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7060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8B253F-ADA3-9741-9A24-4D9422546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1F8A9A5-CDD0-BB4B-B43F-5AF15ADD20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A71A74B-B147-DF41-8211-7CAD92BC6E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670392-45B6-4148-86B0-0AC8CC548E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46ABAF0-89F1-3749-82FB-E7602F1CF6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3988452-0BA2-1844-BBC2-D026F14EB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EF98E1A-BBD6-E94D-BF82-26DB959695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D76E50B-15CF-544F-A89F-041D79AC2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205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4876BB-BAE8-D243-97B3-7FDAC97BF5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D70C0AD-DEC3-864D-A536-89158523A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3DE58C9-CA5A-9A48-B94C-07D5B0B95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9668226-C3CA-5E47-9B24-119C3213DE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9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FA361A0-8B9D-2241-BB07-A445B553B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C91E669-6ABE-894B-A4BA-0324AA02F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F1A5CDA-86FE-9147-92D3-D30EAD215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611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360EBF-7A11-FF4F-98A5-DEC09B61B6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F2FC8AF-7413-9640-83C4-9A80457DFC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186FF7B-D5D1-F94C-BDCE-AE0A1DCFC5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0237F3F-E375-A548-AA14-97894E40E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2B6DD36-9B7A-E54C-BBA7-683017F6B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0FA3990-C178-F646-A2CB-4DC0162C0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4556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55D18A-9CAF-0149-B0C2-39B0D599AE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26C9FA7-2B1A-8042-8542-BB50A7B101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1" indent="0">
              <a:buNone/>
              <a:defRPr sz="2800"/>
            </a:lvl2pPr>
            <a:lvl3pPr marL="914361" indent="0">
              <a:buNone/>
              <a:defRPr sz="2400"/>
            </a:lvl3pPr>
            <a:lvl4pPr marL="1371543" indent="0">
              <a:buNone/>
              <a:defRPr sz="2000"/>
            </a:lvl4pPr>
            <a:lvl5pPr marL="1828724" indent="0">
              <a:buNone/>
              <a:defRPr sz="2000"/>
            </a:lvl5pPr>
            <a:lvl6pPr marL="2285904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7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C306F59-CC9D-4B46-A779-91B0F3C4E3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3F24F17-4631-3F4A-81A4-72FD1DA6D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38BBF1A-AB19-E646-A66F-AC114EB72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7B45440-86CE-4D46-8783-C05A39785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2422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E7FF4F6-F740-504B-A6FF-7E505BD64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3B28E48-BB41-7642-80A1-1D9786993A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259140-D7C6-534E-96D7-302DFF71AF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7C0FA3D-691A-D240-BCA4-9DE17FE38C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F5F42D-BB2A-C740-9D2B-076A395887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8937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1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3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6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61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1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1" algn="l" defTabSz="914361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1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4" algn="l" defTabSz="914361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4" algn="l" defTabSz="914361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1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1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7" algn="l" defTabSz="914361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92B13DAE-0B83-D54D-8BCB-7ADFC190E6C9}"/>
              </a:ext>
            </a:extLst>
          </p:cNvPr>
          <p:cNvSpPr/>
          <p:nvPr/>
        </p:nvSpPr>
        <p:spPr>
          <a:xfrm>
            <a:off x="3474721" y="257521"/>
            <a:ext cx="2797035" cy="84839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A3F13417-CB13-FD4D-A769-6E77FCE1CBAB}"/>
              </a:ext>
            </a:extLst>
          </p:cNvPr>
          <p:cNvCxnSpPr>
            <a:cxnSpLocks/>
            <a:endCxn id="10" idx="0"/>
          </p:cNvCxnSpPr>
          <p:nvPr/>
        </p:nvCxnSpPr>
        <p:spPr>
          <a:xfrm>
            <a:off x="4860925" y="1101566"/>
            <a:ext cx="9358" cy="69254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矢印コネクタ 7">
            <a:extLst>
              <a:ext uri="{FF2B5EF4-FFF2-40B4-BE49-F238E27FC236}">
                <a16:creationId xmlns:a16="http://schemas.microsoft.com/office/drawing/2014/main" id="{C62C8BD9-1B46-8C41-81FE-574954C906FB}"/>
              </a:ext>
            </a:extLst>
          </p:cNvPr>
          <p:cNvCxnSpPr>
            <a:cxnSpLocks/>
            <a:endCxn id="9" idx="1"/>
          </p:cNvCxnSpPr>
          <p:nvPr/>
        </p:nvCxnSpPr>
        <p:spPr>
          <a:xfrm>
            <a:off x="4859383" y="1447837"/>
            <a:ext cx="1160120" cy="245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F528A718-1889-3C41-ADF7-C93AE9B26ECC}"/>
              </a:ext>
            </a:extLst>
          </p:cNvPr>
          <p:cNvSpPr/>
          <p:nvPr/>
        </p:nvSpPr>
        <p:spPr>
          <a:xfrm>
            <a:off x="6019503" y="1216243"/>
            <a:ext cx="1872342" cy="46809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66746F10-006F-3B43-A5E3-FBFA608B8AAE}"/>
              </a:ext>
            </a:extLst>
          </p:cNvPr>
          <p:cNvSpPr/>
          <p:nvPr/>
        </p:nvSpPr>
        <p:spPr>
          <a:xfrm>
            <a:off x="3996316" y="1794110"/>
            <a:ext cx="1747934" cy="50997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5E8804-D97F-0643-97FF-DEB649044144}"/>
              </a:ext>
            </a:extLst>
          </p:cNvPr>
          <p:cNvSpPr txBox="1"/>
          <p:nvPr/>
        </p:nvSpPr>
        <p:spPr>
          <a:xfrm>
            <a:off x="3474721" y="268703"/>
            <a:ext cx="27970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Reports identified from PubMed, Scopus, MEDLINE, and Cochrane Central Register of Controlled Trial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n=1479) </a:t>
            </a: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5E8F56B-7E6A-3447-892F-FB1F8BB02E09}"/>
              </a:ext>
            </a:extLst>
          </p:cNvPr>
          <p:cNvSpPr txBox="1"/>
          <p:nvPr/>
        </p:nvSpPr>
        <p:spPr>
          <a:xfrm>
            <a:off x="6189988" y="1222671"/>
            <a:ext cx="17018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uplicates excluded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n=193) </a:t>
            </a: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19CFDEB-21CC-5F4A-AC8B-302C3D2CEE5D}"/>
              </a:ext>
            </a:extLst>
          </p:cNvPr>
          <p:cNvSpPr txBox="1"/>
          <p:nvPr/>
        </p:nvSpPr>
        <p:spPr>
          <a:xfrm>
            <a:off x="4089620" y="1820695"/>
            <a:ext cx="15541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Reports screened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n=1286) </a:t>
            </a: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C4ECC809-4BC2-D840-BB30-3B2FB6E945E1}"/>
              </a:ext>
            </a:extLst>
          </p:cNvPr>
          <p:cNvCxnSpPr>
            <a:cxnSpLocks/>
          </p:cNvCxnSpPr>
          <p:nvPr/>
        </p:nvCxnSpPr>
        <p:spPr>
          <a:xfrm flipH="1">
            <a:off x="4859383" y="2305934"/>
            <a:ext cx="1542" cy="140391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3A1B1372-05F7-C440-B2AB-1AFDC5B309B2}"/>
              </a:ext>
            </a:extLst>
          </p:cNvPr>
          <p:cNvCxnSpPr>
            <a:cxnSpLocks/>
            <a:endCxn id="29" idx="1"/>
          </p:cNvCxnSpPr>
          <p:nvPr/>
        </p:nvCxnSpPr>
        <p:spPr>
          <a:xfrm>
            <a:off x="4870284" y="3006459"/>
            <a:ext cx="114892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5F4C6DD0-8DD4-4F4E-B92C-AC8BC726C138}"/>
              </a:ext>
            </a:extLst>
          </p:cNvPr>
          <p:cNvSpPr/>
          <p:nvPr/>
        </p:nvSpPr>
        <p:spPr>
          <a:xfrm>
            <a:off x="6019206" y="2296526"/>
            <a:ext cx="2386446" cy="141986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F8D5834-83F5-7C42-BDAC-84CE0E84E8D7}"/>
              </a:ext>
            </a:extLst>
          </p:cNvPr>
          <p:cNvSpPr txBox="1"/>
          <p:nvPr/>
        </p:nvSpPr>
        <p:spPr>
          <a:xfrm>
            <a:off x="6117178" y="2331397"/>
            <a:ext cx="256766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1417638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xcluded (n=1255) </a:t>
            </a:r>
          </a:p>
          <a:p>
            <a:pPr>
              <a:tabLst>
                <a:tab pos="1417638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 Not RCT	(n=1123)</a:t>
            </a:r>
          </a:p>
          <a:p>
            <a:pPr>
              <a:tabLst>
                <a:tab pos="1417638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 Not sarcomas	(n=27)</a:t>
            </a:r>
          </a:p>
          <a:p>
            <a:pPr>
              <a:tabLst>
                <a:tab pos="1417638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 Not soft tissue	(n=19)</a:t>
            </a:r>
          </a:p>
          <a:p>
            <a:pPr>
              <a:tabLst>
                <a:tab pos="1417638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 Not advanced	(n=48)</a:t>
            </a:r>
          </a:p>
          <a:p>
            <a:pPr>
              <a:tabLst>
                <a:tab pos="1417638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 Animal studies	(n=2)</a:t>
            </a:r>
          </a:p>
          <a:p>
            <a:pPr>
              <a:tabLst>
                <a:tab pos="1417638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 Not 1st-line DOX	(n=36)</a:t>
            </a: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3CBC5FF0-B99A-644C-845B-F2336FD3E7AF}"/>
              </a:ext>
            </a:extLst>
          </p:cNvPr>
          <p:cNvSpPr/>
          <p:nvPr/>
        </p:nvSpPr>
        <p:spPr>
          <a:xfrm>
            <a:off x="3996316" y="3709848"/>
            <a:ext cx="1747934" cy="50997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AA06E8F-371F-C84C-85C3-C155923D9250}"/>
              </a:ext>
            </a:extLst>
          </p:cNvPr>
          <p:cNvSpPr txBox="1"/>
          <p:nvPr/>
        </p:nvSpPr>
        <p:spPr>
          <a:xfrm>
            <a:off x="4049523" y="3734002"/>
            <a:ext cx="16474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ull texts screened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n=31) </a:t>
            </a: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5F67FD85-EB03-664E-8E89-379815165925}"/>
              </a:ext>
            </a:extLst>
          </p:cNvPr>
          <p:cNvCxnSpPr>
            <a:cxnSpLocks/>
            <a:stCxn id="36" idx="2"/>
            <a:endCxn id="31" idx="0"/>
          </p:cNvCxnSpPr>
          <p:nvPr/>
        </p:nvCxnSpPr>
        <p:spPr>
          <a:xfrm flipH="1">
            <a:off x="4859383" y="4219822"/>
            <a:ext cx="10900" cy="104619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FAFD6CF0-9FE4-1346-BEE3-50B56B96A4F9}"/>
              </a:ext>
            </a:extLst>
          </p:cNvPr>
          <p:cNvCxnSpPr>
            <a:cxnSpLocks/>
            <a:endCxn id="25" idx="1"/>
          </p:cNvCxnSpPr>
          <p:nvPr/>
        </p:nvCxnSpPr>
        <p:spPr>
          <a:xfrm>
            <a:off x="4859384" y="4677912"/>
            <a:ext cx="1159822" cy="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EE8C114D-8C2B-4B4B-A54D-08139F0E3165}"/>
              </a:ext>
            </a:extLst>
          </p:cNvPr>
          <p:cNvSpPr/>
          <p:nvPr/>
        </p:nvSpPr>
        <p:spPr>
          <a:xfrm>
            <a:off x="6019206" y="4228525"/>
            <a:ext cx="2665638" cy="8987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B9BA941-8FA9-FC4A-BAFD-DF515A2D08BF}"/>
              </a:ext>
            </a:extLst>
          </p:cNvPr>
          <p:cNvSpPr txBox="1"/>
          <p:nvPr/>
        </p:nvSpPr>
        <p:spPr>
          <a:xfrm>
            <a:off x="6117178" y="4259215"/>
            <a:ext cx="256766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1458913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xcluded (n=4) </a:t>
            </a:r>
          </a:p>
          <a:p>
            <a:pPr>
              <a:tabLst>
                <a:tab pos="1458913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 Repeat publication	 	 (n=2)</a:t>
            </a:r>
          </a:p>
          <a:p>
            <a:pPr>
              <a:tabLst>
                <a:tab pos="1458913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 Study protocol only	 (n=1)</a:t>
            </a:r>
          </a:p>
          <a:p>
            <a:pPr>
              <a:tabLst>
                <a:tab pos="1458913" algn="l"/>
              </a:tabLs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 Pediatric population	 (n=1)</a:t>
            </a: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C0EF4344-D90C-254A-A170-47D97ED5D2E9}"/>
              </a:ext>
            </a:extLst>
          </p:cNvPr>
          <p:cNvSpPr/>
          <p:nvPr/>
        </p:nvSpPr>
        <p:spPr>
          <a:xfrm>
            <a:off x="3713414" y="5266018"/>
            <a:ext cx="2291937" cy="50997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A360065-FD58-674D-A916-27D8A6543F0D}"/>
              </a:ext>
            </a:extLst>
          </p:cNvPr>
          <p:cNvSpPr txBox="1"/>
          <p:nvPr/>
        </p:nvSpPr>
        <p:spPr>
          <a:xfrm>
            <a:off x="3777733" y="5314327"/>
            <a:ext cx="216329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Relevant studies included</a:t>
            </a:r>
          </a:p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n=27) </a:t>
            </a: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F3BAADBE-37CC-9846-BD31-BEA0706D668C}"/>
              </a:ext>
            </a:extLst>
          </p:cNvPr>
          <p:cNvSpPr/>
          <p:nvPr/>
        </p:nvSpPr>
        <p:spPr>
          <a:xfrm>
            <a:off x="3019400" y="6103784"/>
            <a:ext cx="689095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 S1. PRISMA flow diagram.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bbreviations: DOX, doxorubicin; RCT, randomized controlled trial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7212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0</TotalTime>
  <Words>92</Words>
  <Application>Microsoft Macintosh PowerPoint</Application>
  <PresentationFormat>ワイド画面</PresentationFormat>
  <Paragraphs>2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仲和宏</dc:creator>
  <cp:lastModifiedBy>田仲和宏</cp:lastModifiedBy>
  <cp:revision>33</cp:revision>
  <cp:lastPrinted>2018-05-19T00:31:52Z</cp:lastPrinted>
  <dcterms:created xsi:type="dcterms:W3CDTF">2018-05-19T00:24:53Z</dcterms:created>
  <dcterms:modified xsi:type="dcterms:W3CDTF">2018-12-11T04:56:35Z</dcterms:modified>
</cp:coreProperties>
</file>